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  <p:sldId id="271" r:id="rId3"/>
    <p:sldId id="272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6" autoAdjust="0"/>
    <p:restoredTop sz="94660"/>
  </p:normalViewPr>
  <p:slideViewPr>
    <p:cSldViewPr snapToGrid="0">
      <p:cViewPr>
        <p:scale>
          <a:sx n="100" d="100"/>
          <a:sy n="100" d="100"/>
        </p:scale>
        <p:origin x="452" y="-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E7F0CC9-8423-DC51-35CE-200402B8FD9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26635E5D-9AC4-F7B6-F1D2-90C199422B3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40AC71C-83C0-3196-5ECE-5049F3297B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F25DE-C656-4783-AA0A-63C86A1F2E88}" type="datetimeFigureOut">
              <a:rPr lang="zh-CN" altLang="en-US" smtClean="0"/>
              <a:t>2026/1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90162F5-0A98-357E-0263-507E993DEB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1551015-FF05-6972-D47A-AAA523FFEF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AB165-F628-4305-B775-B664B54835A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87681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A4163A9-F711-E017-F454-7C7C64C694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C2E0D36-A2F8-033E-2291-02A466E32C8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9A88909-3316-3858-0137-C507FDDBC0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F25DE-C656-4783-AA0A-63C86A1F2E88}" type="datetimeFigureOut">
              <a:rPr lang="zh-CN" altLang="en-US" smtClean="0"/>
              <a:t>2026/1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2EC337D-50B0-A400-151B-73498821F7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E0D1FF7-CACF-2FDB-53A0-E44022D540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AB165-F628-4305-B775-B664B54835A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40177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E2020F0-07E9-98FF-DD7E-7E8349A0B56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218FBC6-D65F-8AC6-4B28-016DB2BA877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694B6F3-86B2-F830-FD22-B7FA2F32FA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F25DE-C656-4783-AA0A-63C86A1F2E88}" type="datetimeFigureOut">
              <a:rPr lang="zh-CN" altLang="en-US" smtClean="0"/>
              <a:t>2026/1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8812822-FA82-A6C3-519C-66053A2F37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5535607-0D6D-B970-0CDB-699E49FF16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AB165-F628-4305-B775-B664B54835A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67662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8CAD95C-E4BA-170B-1039-A0EEF10719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10AE56F-1C4E-FF94-B1DB-E370E5BB203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BB898A7-1AA5-4E00-DC78-580C6ADFBD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F25DE-C656-4783-AA0A-63C86A1F2E88}" type="datetimeFigureOut">
              <a:rPr lang="zh-CN" altLang="en-US" smtClean="0"/>
              <a:t>2026/1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8870D39-668C-3DF9-762A-C67F3F37B8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4C77F62-025D-ADA0-35EF-BB6B051672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AB165-F628-4305-B775-B664B54835A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34239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BAE7B00-9017-8259-B247-F7D7EA0E56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5907756-03D4-69B1-AAB2-B30F88EF99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3A0F401-A252-CAF8-3BBC-F616F0D937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F25DE-C656-4783-AA0A-63C86A1F2E88}" type="datetimeFigureOut">
              <a:rPr lang="zh-CN" altLang="en-US" smtClean="0"/>
              <a:t>2026/1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C56E602-59ED-787F-FC9E-8EEEE4AA35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B0E1348-637C-C786-3B02-79F865C3BA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AB165-F628-4305-B775-B664B54835A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48452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3482E1C-7587-9723-9845-DFC6F7DE52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6811A66-4B20-6ED7-1BB3-622182F26D4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4144988-6588-BE1E-4FB8-86074C63765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877FC94-C131-295B-A919-C34575F48E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F25DE-C656-4783-AA0A-63C86A1F2E88}" type="datetimeFigureOut">
              <a:rPr lang="zh-CN" altLang="en-US" smtClean="0"/>
              <a:t>2026/1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34A3AD0-5D9E-74A2-4E0A-9878376444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9E2EB33-0714-68FB-AF17-BDE4594CA6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AB165-F628-4305-B775-B664B54835A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66527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9CED61B-1F51-6B40-9B54-C511E0FDF5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51CA532-3049-CDF4-191B-692FA9C1EA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427B08A-1DEA-4C9E-D94C-176D1C16DE9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9B3E0AFA-2C8B-23CB-9486-D17BDCE9269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8F6B0E2-62BF-2A97-99A5-263269E2E73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CCB2EF1F-7562-DA99-CE60-B5D4940848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F25DE-C656-4783-AA0A-63C86A1F2E88}" type="datetimeFigureOut">
              <a:rPr lang="zh-CN" altLang="en-US" smtClean="0"/>
              <a:t>2026/1/1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A0EB8C26-3A5E-2052-8B6C-77B4CE845C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F706259F-A9B2-5A75-D791-356A06E142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AB165-F628-4305-B775-B664B54835A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33730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5F42E13-13AD-4D11-4121-399964BBF2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895093AD-9223-E1C7-DB83-1BAE9614D1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F25DE-C656-4783-AA0A-63C86A1F2E88}" type="datetimeFigureOut">
              <a:rPr lang="zh-CN" altLang="en-US" smtClean="0"/>
              <a:t>2026/1/1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AA413C61-B5F1-619E-8547-207E37BB83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3ABFD4CC-7D83-DE2F-A54E-90C3FE40BC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AB165-F628-4305-B775-B664B54835A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77397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11F4591-95F8-27B6-4C93-8CBC0DB41F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F25DE-C656-4783-AA0A-63C86A1F2E88}" type="datetimeFigureOut">
              <a:rPr lang="zh-CN" altLang="en-US" smtClean="0"/>
              <a:t>2026/1/1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E5510D2-F08E-5051-B1D4-28DA3BE938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E872F00E-4ADF-F06F-75B7-2295FF5A8B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AB165-F628-4305-B775-B664B54835A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84991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47AC917-92CB-27A9-D23F-B7CFB0CA82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C3F80D9-09CB-54C3-E635-58017BF24C7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4823AA1-13FD-E931-3F08-D069C93466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F28B327-25BF-A9D6-1199-6FA5B6D25F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F25DE-C656-4783-AA0A-63C86A1F2E88}" type="datetimeFigureOut">
              <a:rPr lang="zh-CN" altLang="en-US" smtClean="0"/>
              <a:t>2026/1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4EF860B-E853-AEA5-5447-591CC6EB13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2684FD2-435A-CEFA-A749-0CD17320BD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AB165-F628-4305-B775-B664B54835A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88294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5593082-38DD-6384-6BA2-BFEC4BC476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E9B61D0-2953-013F-2EC5-9CFA290526C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3DBD17B-2CB9-D26D-6150-1921903D99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A3E7578-C8F4-2BBD-78F2-59297AFFA5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F25DE-C656-4783-AA0A-63C86A1F2E88}" type="datetimeFigureOut">
              <a:rPr lang="zh-CN" altLang="en-US" smtClean="0"/>
              <a:t>2026/1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F588D9D-9DF6-52A6-C9F4-F6B419B172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67EDB01-B09E-52D5-E269-9DB4EE8968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AB165-F628-4305-B775-B664B54835A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41732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A0BA9C72-0499-34F4-425C-9A4B2BCEBC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A6C572F-F5DF-8160-3225-F27FA4B59D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D747EEA-0A10-BEC7-02F7-D2EF91D69EA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BF25DE-C656-4783-AA0A-63C86A1F2E88}" type="datetimeFigureOut">
              <a:rPr lang="zh-CN" altLang="en-US" smtClean="0"/>
              <a:t>2026/1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5074028-8D2B-7B6E-C4DA-F4A44DB9A72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6E6D6D9-9AFE-C218-3EA3-ED2CBB255B4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5AB165-F628-4305-B775-B664B54835A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97482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F9CE1E0-54DC-A339-F470-3A38403D3B5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id="{EB14946B-3316-78D8-2721-53A5E359131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14445805"/>
              </p:ext>
            </p:extLst>
          </p:nvPr>
        </p:nvGraphicFramePr>
        <p:xfrm>
          <a:off x="156001" y="229870"/>
          <a:ext cx="11879998" cy="656244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968372">
                  <a:extLst>
                    <a:ext uri="{9D8B030D-6E8A-4147-A177-3AD203B41FA5}">
                      <a16:colId xmlns:a16="http://schemas.microsoft.com/office/drawing/2014/main" val="4140418932"/>
                    </a:ext>
                  </a:extLst>
                </a:gridCol>
                <a:gridCol w="526426">
                  <a:extLst>
                    <a:ext uri="{9D8B030D-6E8A-4147-A177-3AD203B41FA5}">
                      <a16:colId xmlns:a16="http://schemas.microsoft.com/office/drawing/2014/main" val="417859792"/>
                    </a:ext>
                  </a:extLst>
                </a:gridCol>
                <a:gridCol w="519260">
                  <a:extLst>
                    <a:ext uri="{9D8B030D-6E8A-4147-A177-3AD203B41FA5}">
                      <a16:colId xmlns:a16="http://schemas.microsoft.com/office/drawing/2014/main" val="871695316"/>
                    </a:ext>
                  </a:extLst>
                </a:gridCol>
                <a:gridCol w="519260">
                  <a:extLst>
                    <a:ext uri="{9D8B030D-6E8A-4147-A177-3AD203B41FA5}">
                      <a16:colId xmlns:a16="http://schemas.microsoft.com/office/drawing/2014/main" val="2896836193"/>
                    </a:ext>
                  </a:extLst>
                </a:gridCol>
                <a:gridCol w="519260">
                  <a:extLst>
                    <a:ext uri="{9D8B030D-6E8A-4147-A177-3AD203B41FA5}">
                      <a16:colId xmlns:a16="http://schemas.microsoft.com/office/drawing/2014/main" val="2036519736"/>
                    </a:ext>
                  </a:extLst>
                </a:gridCol>
                <a:gridCol w="519260">
                  <a:extLst>
                    <a:ext uri="{9D8B030D-6E8A-4147-A177-3AD203B41FA5}">
                      <a16:colId xmlns:a16="http://schemas.microsoft.com/office/drawing/2014/main" val="1831084436"/>
                    </a:ext>
                  </a:extLst>
                </a:gridCol>
                <a:gridCol w="519260">
                  <a:extLst>
                    <a:ext uri="{9D8B030D-6E8A-4147-A177-3AD203B41FA5}">
                      <a16:colId xmlns:a16="http://schemas.microsoft.com/office/drawing/2014/main" val="1790857603"/>
                    </a:ext>
                  </a:extLst>
                </a:gridCol>
                <a:gridCol w="519260">
                  <a:extLst>
                    <a:ext uri="{9D8B030D-6E8A-4147-A177-3AD203B41FA5}">
                      <a16:colId xmlns:a16="http://schemas.microsoft.com/office/drawing/2014/main" val="2552498517"/>
                    </a:ext>
                  </a:extLst>
                </a:gridCol>
                <a:gridCol w="519260">
                  <a:extLst>
                    <a:ext uri="{9D8B030D-6E8A-4147-A177-3AD203B41FA5}">
                      <a16:colId xmlns:a16="http://schemas.microsoft.com/office/drawing/2014/main" val="3690620645"/>
                    </a:ext>
                  </a:extLst>
                </a:gridCol>
                <a:gridCol w="519260">
                  <a:extLst>
                    <a:ext uri="{9D8B030D-6E8A-4147-A177-3AD203B41FA5}">
                      <a16:colId xmlns:a16="http://schemas.microsoft.com/office/drawing/2014/main" val="326997168"/>
                    </a:ext>
                  </a:extLst>
                </a:gridCol>
                <a:gridCol w="519260">
                  <a:extLst>
                    <a:ext uri="{9D8B030D-6E8A-4147-A177-3AD203B41FA5}">
                      <a16:colId xmlns:a16="http://schemas.microsoft.com/office/drawing/2014/main" val="3665308213"/>
                    </a:ext>
                  </a:extLst>
                </a:gridCol>
                <a:gridCol w="519260">
                  <a:extLst>
                    <a:ext uri="{9D8B030D-6E8A-4147-A177-3AD203B41FA5}">
                      <a16:colId xmlns:a16="http://schemas.microsoft.com/office/drawing/2014/main" val="2308667532"/>
                    </a:ext>
                  </a:extLst>
                </a:gridCol>
                <a:gridCol w="519260">
                  <a:extLst>
                    <a:ext uri="{9D8B030D-6E8A-4147-A177-3AD203B41FA5}">
                      <a16:colId xmlns:a16="http://schemas.microsoft.com/office/drawing/2014/main" val="2751270164"/>
                    </a:ext>
                  </a:extLst>
                </a:gridCol>
                <a:gridCol w="519260">
                  <a:extLst>
                    <a:ext uri="{9D8B030D-6E8A-4147-A177-3AD203B41FA5}">
                      <a16:colId xmlns:a16="http://schemas.microsoft.com/office/drawing/2014/main" val="1831343115"/>
                    </a:ext>
                  </a:extLst>
                </a:gridCol>
                <a:gridCol w="519260">
                  <a:extLst>
                    <a:ext uri="{9D8B030D-6E8A-4147-A177-3AD203B41FA5}">
                      <a16:colId xmlns:a16="http://schemas.microsoft.com/office/drawing/2014/main" val="3120519479"/>
                    </a:ext>
                  </a:extLst>
                </a:gridCol>
                <a:gridCol w="519260">
                  <a:extLst>
                    <a:ext uri="{9D8B030D-6E8A-4147-A177-3AD203B41FA5}">
                      <a16:colId xmlns:a16="http://schemas.microsoft.com/office/drawing/2014/main" val="3311475189"/>
                    </a:ext>
                  </a:extLst>
                </a:gridCol>
                <a:gridCol w="519260">
                  <a:extLst>
                    <a:ext uri="{9D8B030D-6E8A-4147-A177-3AD203B41FA5}">
                      <a16:colId xmlns:a16="http://schemas.microsoft.com/office/drawing/2014/main" val="1506876765"/>
                    </a:ext>
                  </a:extLst>
                </a:gridCol>
                <a:gridCol w="519260">
                  <a:extLst>
                    <a:ext uri="{9D8B030D-6E8A-4147-A177-3AD203B41FA5}">
                      <a16:colId xmlns:a16="http://schemas.microsoft.com/office/drawing/2014/main" val="1468187841"/>
                    </a:ext>
                  </a:extLst>
                </a:gridCol>
                <a:gridCol w="519260">
                  <a:extLst>
                    <a:ext uri="{9D8B030D-6E8A-4147-A177-3AD203B41FA5}">
                      <a16:colId xmlns:a16="http://schemas.microsoft.com/office/drawing/2014/main" val="727842206"/>
                    </a:ext>
                  </a:extLst>
                </a:gridCol>
                <a:gridCol w="519260">
                  <a:extLst>
                    <a:ext uri="{9D8B030D-6E8A-4147-A177-3AD203B41FA5}">
                      <a16:colId xmlns:a16="http://schemas.microsoft.com/office/drawing/2014/main" val="1576384145"/>
                    </a:ext>
                  </a:extLst>
                </a:gridCol>
                <a:gridCol w="519260">
                  <a:extLst>
                    <a:ext uri="{9D8B030D-6E8A-4147-A177-3AD203B41FA5}">
                      <a16:colId xmlns:a16="http://schemas.microsoft.com/office/drawing/2014/main" val="2435878270"/>
                    </a:ext>
                  </a:extLst>
                </a:gridCol>
                <a:gridCol w="519260">
                  <a:extLst>
                    <a:ext uri="{9D8B030D-6E8A-4147-A177-3AD203B41FA5}">
                      <a16:colId xmlns:a16="http://schemas.microsoft.com/office/drawing/2014/main" val="2476483494"/>
                    </a:ext>
                  </a:extLst>
                </a:gridCol>
              </a:tblGrid>
              <a:tr h="171666">
                <a:tc gridSpan="22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Table S1. Genetic variability at 20 microsatellite loci in 11 populations of </a:t>
                      </a:r>
                      <a:r>
                        <a:rPr lang="en-US" altLang="zh-CN" sz="11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. </a:t>
                      </a:r>
                      <a:r>
                        <a:rPr lang="en-US" altLang="zh-CN" sz="11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senbergii</a:t>
                      </a:r>
                      <a:endParaRPr lang="en-US" altLang="zh-CN" sz="1100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1536451"/>
                  </a:ext>
                </a:extLst>
              </a:tr>
              <a:tr h="337571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tem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9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5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8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1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6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2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3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3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5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1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5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6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2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1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8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1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3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8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4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3238736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ZCX-N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000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000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000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000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000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000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00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000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00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000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000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000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000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00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00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00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00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000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000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00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850013873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43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55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383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380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206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792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53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160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05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33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64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629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373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614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186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90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77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696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433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696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1682101276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52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84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71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74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62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70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69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47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60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10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02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57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31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25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59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74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13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85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70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96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855022448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o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00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00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33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00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33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33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67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93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33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33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33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67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67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67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00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33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00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00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00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67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226476957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18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11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43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72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62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72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75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06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16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31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03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24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14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23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86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14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3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29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74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29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3211291072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64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96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2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37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69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4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4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6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28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04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83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0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8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55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20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94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1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15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54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51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3424753287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100" b="0" u="none" strike="noStrike" kern="120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HWE)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zh-CN" alt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zh-CN" alt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zh-CN" alt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zh-CN" alt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zh-CN" alt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zh-CN" alt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zh-CN" alt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zh-CN" alt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93470506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HZCX-NY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Na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6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8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6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6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9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6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7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7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3782004603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Ne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35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94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1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81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50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80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53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33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50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44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44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11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1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95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71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78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36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91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38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514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138630462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I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9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4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67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46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42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92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99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28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1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3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32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51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51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20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15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14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1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59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68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92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2934312380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Ho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34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1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82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8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2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8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9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1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8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52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3121058760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He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7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8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5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3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1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82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0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33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9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1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5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5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6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3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4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26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4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7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02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75509206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F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9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25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12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02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04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6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03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19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07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12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25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2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19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5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07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2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1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24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84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3893768168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altLang="zh-CN" sz="1100" b="0" u="none" strike="noStrike" kern="120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HWE)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zh-CN" alt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zh-CN" altLang="en-US" sz="1100" b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zh-CN" alt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zh-CN" alt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zh-CN" alt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zh-CN" alt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669793855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HZCX-XN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Na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6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7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6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7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6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6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6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2176446522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Ne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32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95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83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99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76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47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56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08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12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23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40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71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24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62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62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87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22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40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55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675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3439401216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I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99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5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52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27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78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1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29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95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98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94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20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54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12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14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24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39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24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47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107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3591359204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Ho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3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8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8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3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3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67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1246672836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He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7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8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3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4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3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81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0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7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2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5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8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3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6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1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1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5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18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8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1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26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372424420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F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12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31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5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11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04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14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14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16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13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02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08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15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13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0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3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02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4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8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9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065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2733558435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altLang="zh-CN" sz="1100" b="0" u="none" strike="noStrike" kern="120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HWE)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1100" b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486789406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HZCX-ZY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Na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6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7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6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6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3657397946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Ne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82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6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70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64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62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34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57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6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85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06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36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32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6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22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05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63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14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77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71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267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1530158616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I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15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85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41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17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37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66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1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32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80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6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2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32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46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27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97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32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28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56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46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264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3960932030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Ho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3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5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1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8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8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3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8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1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8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2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800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843769175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He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4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37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3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2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2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7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1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2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6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1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7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9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5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8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1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2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12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3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3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94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382098260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F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03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11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10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14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3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12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1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3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15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03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7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9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10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6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2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10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05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08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3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153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108249892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altLang="zh-CN" sz="1100" b="0" u="none" strike="noStrike" kern="120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HWE)</a:t>
                      </a:r>
                    </a:p>
                  </a:txBody>
                  <a:tcPr marL="5761" marR="5761" marT="576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*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*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*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*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10454180"/>
                  </a:ext>
                </a:extLst>
              </a:tr>
            </a:tbl>
          </a:graphicData>
        </a:graphic>
      </p:graphicFrame>
      <p:sp>
        <p:nvSpPr>
          <p:cNvPr id="3" name="TextBox 57">
            <a:extLst>
              <a:ext uri="{FF2B5EF4-FFF2-40B4-BE49-F238E27FC236}">
                <a16:creationId xmlns:a16="http://schemas.microsoft.com/office/drawing/2014/main" id="{6D439330-0F9F-DE6B-E245-95FBDF34451F}"/>
              </a:ext>
            </a:extLst>
          </p:cNvPr>
          <p:cNvSpPr txBox="1"/>
          <p:nvPr/>
        </p:nvSpPr>
        <p:spPr>
          <a:xfrm>
            <a:off x="565816" y="0"/>
            <a:ext cx="27657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noProof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Jiao </a:t>
            </a:r>
            <a:r>
              <a:rPr lang="en-US" altLang="zh-CN" sz="1200" b="1" i="1" noProof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et al.  </a:t>
            </a:r>
            <a:r>
              <a:rPr lang="en-US" altLang="zh-CN" sz="1200" b="1" noProof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able S1</a:t>
            </a:r>
            <a:endParaRPr lang="zh-CN" altLang="en-US" sz="1200" b="1" noProof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945538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3C7C08C-5E89-5DA0-06AC-B0C5859F342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id="{05420959-5311-EEE9-ACA9-86D4E7CC1C7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14844666"/>
              </p:ext>
            </p:extLst>
          </p:nvPr>
        </p:nvGraphicFramePr>
        <p:xfrm>
          <a:off x="155996" y="403271"/>
          <a:ext cx="11878284" cy="6389041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961604">
                  <a:extLst>
                    <a:ext uri="{9D8B030D-6E8A-4147-A177-3AD203B41FA5}">
                      <a16:colId xmlns:a16="http://schemas.microsoft.com/office/drawing/2014/main" val="4140418932"/>
                    </a:ext>
                  </a:extLst>
                </a:gridCol>
                <a:gridCol w="525600">
                  <a:extLst>
                    <a:ext uri="{9D8B030D-6E8A-4147-A177-3AD203B41FA5}">
                      <a16:colId xmlns:a16="http://schemas.microsoft.com/office/drawing/2014/main" val="417859792"/>
                    </a:ext>
                  </a:extLst>
                </a:gridCol>
                <a:gridCol w="519554">
                  <a:extLst>
                    <a:ext uri="{9D8B030D-6E8A-4147-A177-3AD203B41FA5}">
                      <a16:colId xmlns:a16="http://schemas.microsoft.com/office/drawing/2014/main" val="871695316"/>
                    </a:ext>
                  </a:extLst>
                </a:gridCol>
                <a:gridCol w="519554">
                  <a:extLst>
                    <a:ext uri="{9D8B030D-6E8A-4147-A177-3AD203B41FA5}">
                      <a16:colId xmlns:a16="http://schemas.microsoft.com/office/drawing/2014/main" val="2896836193"/>
                    </a:ext>
                  </a:extLst>
                </a:gridCol>
                <a:gridCol w="519554">
                  <a:extLst>
                    <a:ext uri="{9D8B030D-6E8A-4147-A177-3AD203B41FA5}">
                      <a16:colId xmlns:a16="http://schemas.microsoft.com/office/drawing/2014/main" val="2036519736"/>
                    </a:ext>
                  </a:extLst>
                </a:gridCol>
                <a:gridCol w="519554">
                  <a:extLst>
                    <a:ext uri="{9D8B030D-6E8A-4147-A177-3AD203B41FA5}">
                      <a16:colId xmlns:a16="http://schemas.microsoft.com/office/drawing/2014/main" val="1831084436"/>
                    </a:ext>
                  </a:extLst>
                </a:gridCol>
                <a:gridCol w="519554">
                  <a:extLst>
                    <a:ext uri="{9D8B030D-6E8A-4147-A177-3AD203B41FA5}">
                      <a16:colId xmlns:a16="http://schemas.microsoft.com/office/drawing/2014/main" val="1790857603"/>
                    </a:ext>
                  </a:extLst>
                </a:gridCol>
                <a:gridCol w="519554">
                  <a:extLst>
                    <a:ext uri="{9D8B030D-6E8A-4147-A177-3AD203B41FA5}">
                      <a16:colId xmlns:a16="http://schemas.microsoft.com/office/drawing/2014/main" val="2552498517"/>
                    </a:ext>
                  </a:extLst>
                </a:gridCol>
                <a:gridCol w="519554">
                  <a:extLst>
                    <a:ext uri="{9D8B030D-6E8A-4147-A177-3AD203B41FA5}">
                      <a16:colId xmlns:a16="http://schemas.microsoft.com/office/drawing/2014/main" val="3690620645"/>
                    </a:ext>
                  </a:extLst>
                </a:gridCol>
                <a:gridCol w="519554">
                  <a:extLst>
                    <a:ext uri="{9D8B030D-6E8A-4147-A177-3AD203B41FA5}">
                      <a16:colId xmlns:a16="http://schemas.microsoft.com/office/drawing/2014/main" val="326997168"/>
                    </a:ext>
                  </a:extLst>
                </a:gridCol>
                <a:gridCol w="519554">
                  <a:extLst>
                    <a:ext uri="{9D8B030D-6E8A-4147-A177-3AD203B41FA5}">
                      <a16:colId xmlns:a16="http://schemas.microsoft.com/office/drawing/2014/main" val="3665308213"/>
                    </a:ext>
                  </a:extLst>
                </a:gridCol>
                <a:gridCol w="519554">
                  <a:extLst>
                    <a:ext uri="{9D8B030D-6E8A-4147-A177-3AD203B41FA5}">
                      <a16:colId xmlns:a16="http://schemas.microsoft.com/office/drawing/2014/main" val="2308667532"/>
                    </a:ext>
                  </a:extLst>
                </a:gridCol>
                <a:gridCol w="519554">
                  <a:extLst>
                    <a:ext uri="{9D8B030D-6E8A-4147-A177-3AD203B41FA5}">
                      <a16:colId xmlns:a16="http://schemas.microsoft.com/office/drawing/2014/main" val="2751270164"/>
                    </a:ext>
                  </a:extLst>
                </a:gridCol>
                <a:gridCol w="519554">
                  <a:extLst>
                    <a:ext uri="{9D8B030D-6E8A-4147-A177-3AD203B41FA5}">
                      <a16:colId xmlns:a16="http://schemas.microsoft.com/office/drawing/2014/main" val="1831343115"/>
                    </a:ext>
                  </a:extLst>
                </a:gridCol>
                <a:gridCol w="519554">
                  <a:extLst>
                    <a:ext uri="{9D8B030D-6E8A-4147-A177-3AD203B41FA5}">
                      <a16:colId xmlns:a16="http://schemas.microsoft.com/office/drawing/2014/main" val="3120519479"/>
                    </a:ext>
                  </a:extLst>
                </a:gridCol>
                <a:gridCol w="519554">
                  <a:extLst>
                    <a:ext uri="{9D8B030D-6E8A-4147-A177-3AD203B41FA5}">
                      <a16:colId xmlns:a16="http://schemas.microsoft.com/office/drawing/2014/main" val="3311475189"/>
                    </a:ext>
                  </a:extLst>
                </a:gridCol>
                <a:gridCol w="519554">
                  <a:extLst>
                    <a:ext uri="{9D8B030D-6E8A-4147-A177-3AD203B41FA5}">
                      <a16:colId xmlns:a16="http://schemas.microsoft.com/office/drawing/2014/main" val="1506876765"/>
                    </a:ext>
                  </a:extLst>
                </a:gridCol>
                <a:gridCol w="519554">
                  <a:extLst>
                    <a:ext uri="{9D8B030D-6E8A-4147-A177-3AD203B41FA5}">
                      <a16:colId xmlns:a16="http://schemas.microsoft.com/office/drawing/2014/main" val="1468187841"/>
                    </a:ext>
                  </a:extLst>
                </a:gridCol>
                <a:gridCol w="519554">
                  <a:extLst>
                    <a:ext uri="{9D8B030D-6E8A-4147-A177-3AD203B41FA5}">
                      <a16:colId xmlns:a16="http://schemas.microsoft.com/office/drawing/2014/main" val="727842206"/>
                    </a:ext>
                  </a:extLst>
                </a:gridCol>
                <a:gridCol w="519554">
                  <a:extLst>
                    <a:ext uri="{9D8B030D-6E8A-4147-A177-3AD203B41FA5}">
                      <a16:colId xmlns:a16="http://schemas.microsoft.com/office/drawing/2014/main" val="1576384145"/>
                    </a:ext>
                  </a:extLst>
                </a:gridCol>
                <a:gridCol w="519554">
                  <a:extLst>
                    <a:ext uri="{9D8B030D-6E8A-4147-A177-3AD203B41FA5}">
                      <a16:colId xmlns:a16="http://schemas.microsoft.com/office/drawing/2014/main" val="2435878270"/>
                    </a:ext>
                  </a:extLst>
                </a:gridCol>
                <a:gridCol w="519554">
                  <a:extLst>
                    <a:ext uri="{9D8B030D-6E8A-4147-A177-3AD203B41FA5}">
                      <a16:colId xmlns:a16="http://schemas.microsoft.com/office/drawing/2014/main" val="2476483494"/>
                    </a:ext>
                  </a:extLst>
                </a:gridCol>
              </a:tblGrid>
              <a:tr h="340907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tem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9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5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8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1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6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2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3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3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5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1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5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6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2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1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8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1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3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8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4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3238736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MD-ZJ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Na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850013873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Ne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98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3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64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85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92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62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8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60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0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94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37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05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89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675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1682101276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I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8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8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8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7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7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2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5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2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6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7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2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9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6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6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87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855022448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Ho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9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34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00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226476957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He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9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39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4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8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38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6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1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1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8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7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1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7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26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3211291072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F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14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#N/A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01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#N/A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36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38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11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30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13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#N/A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#N/A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62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93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93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15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0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#N/A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17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26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597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3424753287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P</a:t>
                      </a:r>
                      <a:r>
                        <a:rPr lang="en-US" altLang="zh-CN" sz="1100" b="0" u="none" strike="noStrike" kern="120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HWE)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altLang="zh-CN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--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altLang="zh-CN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--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zh-CN" alt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zh-CN" alt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altLang="zh-CN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--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altLang="zh-CN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--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zh-CN" alt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**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zh-CN" alt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**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zh-CN" alt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**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altLang="zh-CN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--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zh-CN" alt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***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63768674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MJ-GX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Na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6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000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3782004603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Ne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74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84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74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96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50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22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88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11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93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19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09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91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17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43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7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7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03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93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476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138630462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I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14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14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9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9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7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55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82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4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91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92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33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89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32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6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4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4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22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17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86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2934312380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Ho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9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15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9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1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92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1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9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1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1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5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30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15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30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6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23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3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9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385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3121058760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He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3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4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2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6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0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6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7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2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8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4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7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7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14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8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2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2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7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6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322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75509206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F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57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06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3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04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02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20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30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31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27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#N/A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13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10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35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06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7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09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5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0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04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193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3893768168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P</a:t>
                      </a:r>
                      <a:r>
                        <a:rPr lang="en-US" altLang="zh-CN" sz="1100" b="0" u="none" strike="noStrike" kern="120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HWE)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**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--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*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056720918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SL-GX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Na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7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000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2176446522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Ne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56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47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22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42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93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45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77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59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50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41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22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82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96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95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63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6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65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72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17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562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3439401216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I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5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97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25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4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22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70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3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1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31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6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34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36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90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85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38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0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2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1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90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46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3591359204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Ho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6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0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1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17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0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2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2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7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94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23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4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6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8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7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0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35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8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2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2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71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1246672836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He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36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9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9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29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5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7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3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1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1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29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9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3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9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9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2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38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2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2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4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360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372424420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F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82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18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0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1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07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19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20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23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31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19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6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03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19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3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2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8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5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2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15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308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2733558435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P</a:t>
                      </a:r>
                      <a:r>
                        <a:rPr lang="en-US" altLang="zh-CN" sz="1100" b="0" u="none" strike="noStrike" kern="120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HWE)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**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*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**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668920718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G-ZJ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Na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7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8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2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0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8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0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6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8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1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8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6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8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7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8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000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3657397946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Ne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44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04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7.28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75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63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5.07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29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79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40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81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48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35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90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61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05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51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85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2.32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99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005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1530158616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I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79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15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20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68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51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82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27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95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5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72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35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92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60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18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20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34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45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65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37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261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3960932030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Ho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7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5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8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3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37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5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1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00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843769175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He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81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1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86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3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2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93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9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4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28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9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1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81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4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1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7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0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4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91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6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67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382098260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F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3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11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22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03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4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15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4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12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16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3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07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18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14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38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2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14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14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2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19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101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108249892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P</a:t>
                      </a:r>
                      <a:r>
                        <a:rPr lang="en-US" altLang="zh-CN" sz="1100" b="0" u="none" strike="noStrike" kern="120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HWE)</a:t>
                      </a:r>
                    </a:p>
                  </a:txBody>
                  <a:tcPr marL="5761" marR="5761" marT="576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*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**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***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**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***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04985233"/>
                  </a:ext>
                </a:extLst>
              </a:tr>
            </a:tbl>
          </a:graphicData>
        </a:graphic>
      </p:graphicFrame>
      <p:sp>
        <p:nvSpPr>
          <p:cNvPr id="3" name="文本框 2">
            <a:extLst>
              <a:ext uri="{FF2B5EF4-FFF2-40B4-BE49-F238E27FC236}">
                <a16:creationId xmlns:a16="http://schemas.microsoft.com/office/drawing/2014/main" id="{5AD66246-58A5-EF56-DA15-7A82319E6215}"/>
              </a:ext>
            </a:extLst>
          </p:cNvPr>
          <p:cNvSpPr txBox="1"/>
          <p:nvPr/>
        </p:nvSpPr>
        <p:spPr>
          <a:xfrm>
            <a:off x="565820" y="148674"/>
            <a:ext cx="936349" cy="2682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43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ontinued)</a:t>
            </a:r>
          </a:p>
        </p:txBody>
      </p:sp>
      <p:sp>
        <p:nvSpPr>
          <p:cNvPr id="4" name="TextBox 57">
            <a:extLst>
              <a:ext uri="{FF2B5EF4-FFF2-40B4-BE49-F238E27FC236}">
                <a16:creationId xmlns:a16="http://schemas.microsoft.com/office/drawing/2014/main" id="{BA47D9E8-3DCD-DA9E-1B59-DA77338271B0}"/>
              </a:ext>
            </a:extLst>
          </p:cNvPr>
          <p:cNvSpPr txBox="1"/>
          <p:nvPr/>
        </p:nvSpPr>
        <p:spPr>
          <a:xfrm>
            <a:off x="565819" y="-1699"/>
            <a:ext cx="27657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noProof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Jiao </a:t>
            </a:r>
            <a:r>
              <a:rPr lang="en-US" altLang="zh-CN" sz="1200" b="1" i="1" noProof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et al.  </a:t>
            </a:r>
            <a:r>
              <a:rPr lang="en-US" altLang="zh-CN" sz="1200" b="1" noProof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able S1</a:t>
            </a:r>
            <a:endParaRPr lang="zh-CN" altLang="en-US" sz="1200" b="1" noProof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395027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E45F4D1-B2EC-C80D-F47B-2C61D4832DB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id="{F4DDE9AC-D5A6-1EEA-95C5-8170EAB3F5C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78668052"/>
              </p:ext>
            </p:extLst>
          </p:nvPr>
        </p:nvGraphicFramePr>
        <p:xfrm>
          <a:off x="156002" y="711109"/>
          <a:ext cx="11859880" cy="521808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961200">
                  <a:extLst>
                    <a:ext uri="{9D8B030D-6E8A-4147-A177-3AD203B41FA5}">
                      <a16:colId xmlns:a16="http://schemas.microsoft.com/office/drawing/2014/main" val="4140418932"/>
                    </a:ext>
                  </a:extLst>
                </a:gridCol>
                <a:gridCol w="525600">
                  <a:extLst>
                    <a:ext uri="{9D8B030D-6E8A-4147-A177-3AD203B41FA5}">
                      <a16:colId xmlns:a16="http://schemas.microsoft.com/office/drawing/2014/main" val="417859792"/>
                    </a:ext>
                  </a:extLst>
                </a:gridCol>
                <a:gridCol w="518654">
                  <a:extLst>
                    <a:ext uri="{9D8B030D-6E8A-4147-A177-3AD203B41FA5}">
                      <a16:colId xmlns:a16="http://schemas.microsoft.com/office/drawing/2014/main" val="871695316"/>
                    </a:ext>
                  </a:extLst>
                </a:gridCol>
                <a:gridCol w="518654">
                  <a:extLst>
                    <a:ext uri="{9D8B030D-6E8A-4147-A177-3AD203B41FA5}">
                      <a16:colId xmlns:a16="http://schemas.microsoft.com/office/drawing/2014/main" val="2896836193"/>
                    </a:ext>
                  </a:extLst>
                </a:gridCol>
                <a:gridCol w="518654">
                  <a:extLst>
                    <a:ext uri="{9D8B030D-6E8A-4147-A177-3AD203B41FA5}">
                      <a16:colId xmlns:a16="http://schemas.microsoft.com/office/drawing/2014/main" val="2036519736"/>
                    </a:ext>
                  </a:extLst>
                </a:gridCol>
                <a:gridCol w="518654">
                  <a:extLst>
                    <a:ext uri="{9D8B030D-6E8A-4147-A177-3AD203B41FA5}">
                      <a16:colId xmlns:a16="http://schemas.microsoft.com/office/drawing/2014/main" val="1831084436"/>
                    </a:ext>
                  </a:extLst>
                </a:gridCol>
                <a:gridCol w="518654">
                  <a:extLst>
                    <a:ext uri="{9D8B030D-6E8A-4147-A177-3AD203B41FA5}">
                      <a16:colId xmlns:a16="http://schemas.microsoft.com/office/drawing/2014/main" val="1790857603"/>
                    </a:ext>
                  </a:extLst>
                </a:gridCol>
                <a:gridCol w="518654">
                  <a:extLst>
                    <a:ext uri="{9D8B030D-6E8A-4147-A177-3AD203B41FA5}">
                      <a16:colId xmlns:a16="http://schemas.microsoft.com/office/drawing/2014/main" val="2552498517"/>
                    </a:ext>
                  </a:extLst>
                </a:gridCol>
                <a:gridCol w="518654">
                  <a:extLst>
                    <a:ext uri="{9D8B030D-6E8A-4147-A177-3AD203B41FA5}">
                      <a16:colId xmlns:a16="http://schemas.microsoft.com/office/drawing/2014/main" val="3690620645"/>
                    </a:ext>
                  </a:extLst>
                </a:gridCol>
                <a:gridCol w="518654">
                  <a:extLst>
                    <a:ext uri="{9D8B030D-6E8A-4147-A177-3AD203B41FA5}">
                      <a16:colId xmlns:a16="http://schemas.microsoft.com/office/drawing/2014/main" val="326997168"/>
                    </a:ext>
                  </a:extLst>
                </a:gridCol>
                <a:gridCol w="518654">
                  <a:extLst>
                    <a:ext uri="{9D8B030D-6E8A-4147-A177-3AD203B41FA5}">
                      <a16:colId xmlns:a16="http://schemas.microsoft.com/office/drawing/2014/main" val="3665308213"/>
                    </a:ext>
                  </a:extLst>
                </a:gridCol>
                <a:gridCol w="518654">
                  <a:extLst>
                    <a:ext uri="{9D8B030D-6E8A-4147-A177-3AD203B41FA5}">
                      <a16:colId xmlns:a16="http://schemas.microsoft.com/office/drawing/2014/main" val="2308667532"/>
                    </a:ext>
                  </a:extLst>
                </a:gridCol>
                <a:gridCol w="518654">
                  <a:extLst>
                    <a:ext uri="{9D8B030D-6E8A-4147-A177-3AD203B41FA5}">
                      <a16:colId xmlns:a16="http://schemas.microsoft.com/office/drawing/2014/main" val="2751270164"/>
                    </a:ext>
                  </a:extLst>
                </a:gridCol>
                <a:gridCol w="518654">
                  <a:extLst>
                    <a:ext uri="{9D8B030D-6E8A-4147-A177-3AD203B41FA5}">
                      <a16:colId xmlns:a16="http://schemas.microsoft.com/office/drawing/2014/main" val="1831343115"/>
                    </a:ext>
                  </a:extLst>
                </a:gridCol>
                <a:gridCol w="518654">
                  <a:extLst>
                    <a:ext uri="{9D8B030D-6E8A-4147-A177-3AD203B41FA5}">
                      <a16:colId xmlns:a16="http://schemas.microsoft.com/office/drawing/2014/main" val="3120519479"/>
                    </a:ext>
                  </a:extLst>
                </a:gridCol>
                <a:gridCol w="518654">
                  <a:extLst>
                    <a:ext uri="{9D8B030D-6E8A-4147-A177-3AD203B41FA5}">
                      <a16:colId xmlns:a16="http://schemas.microsoft.com/office/drawing/2014/main" val="3311475189"/>
                    </a:ext>
                  </a:extLst>
                </a:gridCol>
                <a:gridCol w="518654">
                  <a:extLst>
                    <a:ext uri="{9D8B030D-6E8A-4147-A177-3AD203B41FA5}">
                      <a16:colId xmlns:a16="http://schemas.microsoft.com/office/drawing/2014/main" val="1506876765"/>
                    </a:ext>
                  </a:extLst>
                </a:gridCol>
                <a:gridCol w="518654">
                  <a:extLst>
                    <a:ext uri="{9D8B030D-6E8A-4147-A177-3AD203B41FA5}">
                      <a16:colId xmlns:a16="http://schemas.microsoft.com/office/drawing/2014/main" val="1468187841"/>
                    </a:ext>
                  </a:extLst>
                </a:gridCol>
                <a:gridCol w="518654">
                  <a:extLst>
                    <a:ext uri="{9D8B030D-6E8A-4147-A177-3AD203B41FA5}">
                      <a16:colId xmlns:a16="http://schemas.microsoft.com/office/drawing/2014/main" val="727842206"/>
                    </a:ext>
                  </a:extLst>
                </a:gridCol>
                <a:gridCol w="518654">
                  <a:extLst>
                    <a:ext uri="{9D8B030D-6E8A-4147-A177-3AD203B41FA5}">
                      <a16:colId xmlns:a16="http://schemas.microsoft.com/office/drawing/2014/main" val="1576384145"/>
                    </a:ext>
                  </a:extLst>
                </a:gridCol>
                <a:gridCol w="518654">
                  <a:extLst>
                    <a:ext uri="{9D8B030D-6E8A-4147-A177-3AD203B41FA5}">
                      <a16:colId xmlns:a16="http://schemas.microsoft.com/office/drawing/2014/main" val="2435878270"/>
                    </a:ext>
                  </a:extLst>
                </a:gridCol>
                <a:gridCol w="518654">
                  <a:extLst>
                    <a:ext uri="{9D8B030D-6E8A-4147-A177-3AD203B41FA5}">
                      <a16:colId xmlns:a16="http://schemas.microsoft.com/office/drawing/2014/main" val="2476483494"/>
                    </a:ext>
                  </a:extLst>
                </a:gridCol>
              </a:tblGrid>
              <a:tr h="337571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tem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9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5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8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1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6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2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3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3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5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1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5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6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2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1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8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1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3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8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ZX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4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3238736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W-ZJ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Na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8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6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9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6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7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3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7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6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8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7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9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850013873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Ne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96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14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96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29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11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7.53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35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56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29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29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57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72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6.3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93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62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33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65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97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4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769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1682101276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I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7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34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92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14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74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21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99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5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8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66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56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92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92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58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6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3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40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84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54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108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855022448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Ho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5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2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7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9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82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2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9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31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27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33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226476957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He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9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8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83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6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80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8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7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35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6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8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2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84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4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1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7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2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9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7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39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3211291072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F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30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06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7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29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29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21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33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20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5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17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05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36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5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8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13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24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22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5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39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09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3424753287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P</a:t>
                      </a:r>
                      <a:r>
                        <a:rPr lang="en-US" altLang="zh-CN" sz="1100" b="0" u="none" strike="noStrike" kern="120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HWE)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zh-CN" alt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*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zh-CN" alt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zh-CN" alt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**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zh-CN" alt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**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zh-CN" alt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**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zh-CN" alt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zh-CN" alt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**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zh-CN" alt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**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buNone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883948044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ZHL-DH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Na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6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6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7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7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1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7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6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6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7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7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7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3782004603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Ne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62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10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89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30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19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37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10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91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84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62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66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71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62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88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03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72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92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55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98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218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138630462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I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63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37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72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32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45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91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85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60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9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2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47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52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67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4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90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34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84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25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44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10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2934312380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Ho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2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3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86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2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82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3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10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43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3121058760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He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8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7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9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9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8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81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2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4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5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38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2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3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8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4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0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3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8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0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6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49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75509206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F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5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5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24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23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11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18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9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11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5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21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00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13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2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6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24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4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1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2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83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171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3893768168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P</a:t>
                      </a:r>
                      <a:r>
                        <a:rPr lang="en-US" altLang="zh-CN" sz="1100" b="0" u="none" strike="noStrike" kern="120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HWE)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**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**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*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*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**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**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**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10500943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YZJD-YY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Na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6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6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8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6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7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1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6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7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9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7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6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000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2176446522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Ne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74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39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75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57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71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.51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40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8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21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26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52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75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6.83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72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13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01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61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.85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.20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880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3439401216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I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66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48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75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64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74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81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35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52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03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12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19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51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.0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41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36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24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5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63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71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.247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3591359204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Ho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86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4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5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8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86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89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0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8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2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33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8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55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4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5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267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67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1246672836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He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8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0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90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8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8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7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06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4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4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5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0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3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854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32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8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6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379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741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808</a:t>
                      </a:r>
                    </a:p>
                  </a:txBody>
                  <a:tcPr marL="5761" marR="5761" marT="5761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53</a:t>
                      </a:r>
                    </a:p>
                  </a:txBody>
                  <a:tcPr marL="5761" marR="5761" marT="5761" marB="0" anchor="ctr"/>
                </a:tc>
                <a:extLst>
                  <a:ext uri="{0D108BD9-81ED-4DB2-BD59-A6C34878D82A}">
                    <a16:rowId xmlns:a16="http://schemas.microsoft.com/office/drawing/2014/main" val="372424420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F</a:t>
                      </a:r>
                    </a:p>
                  </a:txBody>
                  <a:tcPr marL="5761" marR="5761" marT="5761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198</a:t>
                      </a:r>
                    </a:p>
                  </a:txBody>
                  <a:tcPr marL="5761" marR="5761" marT="5761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244</a:t>
                      </a:r>
                    </a:p>
                  </a:txBody>
                  <a:tcPr marL="5761" marR="5761" marT="5761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092</a:t>
                      </a:r>
                    </a:p>
                  </a:txBody>
                  <a:tcPr marL="5761" marR="5761" marT="5761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52</a:t>
                      </a:r>
                    </a:p>
                  </a:txBody>
                  <a:tcPr marL="5761" marR="5761" marT="5761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37</a:t>
                      </a:r>
                    </a:p>
                  </a:txBody>
                  <a:tcPr marL="5761" marR="5761" marT="5761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009</a:t>
                      </a:r>
                    </a:p>
                  </a:txBody>
                  <a:tcPr marL="5761" marR="5761" marT="5761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221</a:t>
                      </a:r>
                    </a:p>
                  </a:txBody>
                  <a:tcPr marL="5761" marR="5761" marT="5761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209</a:t>
                      </a:r>
                    </a:p>
                  </a:txBody>
                  <a:tcPr marL="5761" marR="5761" marT="5761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27</a:t>
                      </a:r>
                    </a:p>
                  </a:txBody>
                  <a:tcPr marL="5761" marR="5761" marT="5761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076</a:t>
                      </a:r>
                    </a:p>
                  </a:txBody>
                  <a:tcPr marL="5761" marR="5761" marT="5761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62</a:t>
                      </a:r>
                    </a:p>
                  </a:txBody>
                  <a:tcPr marL="5761" marR="5761" marT="5761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201</a:t>
                      </a:r>
                    </a:p>
                  </a:txBody>
                  <a:tcPr marL="5761" marR="5761" marT="5761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152</a:t>
                      </a:r>
                    </a:p>
                  </a:txBody>
                  <a:tcPr marL="5761" marR="5761" marT="5761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271</a:t>
                      </a:r>
                    </a:p>
                  </a:txBody>
                  <a:tcPr marL="5761" marR="5761" marT="5761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140</a:t>
                      </a:r>
                    </a:p>
                  </a:txBody>
                  <a:tcPr marL="5761" marR="5761" marT="5761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20</a:t>
                      </a:r>
                    </a:p>
                  </a:txBody>
                  <a:tcPr marL="5761" marR="5761" marT="5761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184</a:t>
                      </a:r>
                    </a:p>
                  </a:txBody>
                  <a:tcPr marL="5761" marR="5761" marT="5761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255</a:t>
                      </a:r>
                    </a:p>
                  </a:txBody>
                  <a:tcPr marL="5761" marR="5761" marT="5761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670</a:t>
                      </a:r>
                    </a:p>
                  </a:txBody>
                  <a:tcPr marL="5761" marR="5761" marT="5761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0.174</a:t>
                      </a:r>
                    </a:p>
                  </a:txBody>
                  <a:tcPr marL="5761" marR="5761" marT="5761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3558435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P</a:t>
                      </a:r>
                      <a:r>
                        <a:rPr lang="en-US" altLang="zh-CN" sz="1100" b="0" u="none" strike="noStrike" kern="120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HWE)</a:t>
                      </a:r>
                    </a:p>
                  </a:txBody>
                  <a:tcPr marL="5761" marR="5761" marT="5761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*</a:t>
                      </a: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*</a:t>
                      </a: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***</a:t>
                      </a: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ns</a:t>
                      </a:r>
                    </a:p>
                  </a:txBody>
                  <a:tcPr marL="6350" marR="6350" marT="635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8129585"/>
                  </a:ext>
                </a:extLst>
              </a:tr>
              <a:tr h="216000">
                <a:tc gridSpan="22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Note: P</a:t>
                      </a:r>
                      <a:r>
                        <a:rPr lang="en-US" altLang="zh-CN" sz="11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(HWE)</a:t>
                      </a: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, represented Hardy-Weinberg equilibrium. ns </a:t>
                      </a: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eans insignificant</a:t>
                      </a: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, </a:t>
                      </a: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, * indicates a significant difference at </a:t>
                      </a:r>
                      <a:r>
                        <a:rPr lang="en-US" altLang="zh-CN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&lt; 0.05,  ** means a significant difference at </a:t>
                      </a:r>
                      <a:r>
                        <a:rPr lang="en-US" altLang="zh-CN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&lt; 0.01, and ***means a significant difference at </a:t>
                      </a:r>
                      <a:r>
                        <a:rPr lang="en-US" altLang="zh-CN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&lt; 0.001, “</a:t>
                      </a:r>
                      <a:r>
                        <a:rPr lang="en-US" altLang="zh-CN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--</a:t>
                      </a: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” means that the Hardy–Weinberg equilibrium could not be calculated because the locus was monomorphic in that population.</a:t>
                      </a:r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01916531"/>
                  </a:ext>
                </a:extLst>
              </a:tr>
            </a:tbl>
          </a:graphicData>
        </a:graphic>
      </p:graphicFrame>
      <p:sp>
        <p:nvSpPr>
          <p:cNvPr id="3" name="文本框 2">
            <a:extLst>
              <a:ext uri="{FF2B5EF4-FFF2-40B4-BE49-F238E27FC236}">
                <a16:creationId xmlns:a16="http://schemas.microsoft.com/office/drawing/2014/main" id="{48C07933-5581-7BEA-FDB5-B6256B12B6B7}"/>
              </a:ext>
            </a:extLst>
          </p:cNvPr>
          <p:cNvSpPr txBox="1"/>
          <p:nvPr/>
        </p:nvSpPr>
        <p:spPr>
          <a:xfrm>
            <a:off x="565816" y="442894"/>
            <a:ext cx="936349" cy="2682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43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ontinued)</a:t>
            </a:r>
          </a:p>
        </p:txBody>
      </p:sp>
      <p:sp>
        <p:nvSpPr>
          <p:cNvPr id="4" name="TextBox 57">
            <a:extLst>
              <a:ext uri="{FF2B5EF4-FFF2-40B4-BE49-F238E27FC236}">
                <a16:creationId xmlns:a16="http://schemas.microsoft.com/office/drawing/2014/main" id="{12649962-4072-ECAF-F2C8-F162721B8502}"/>
              </a:ext>
            </a:extLst>
          </p:cNvPr>
          <p:cNvSpPr txBox="1"/>
          <p:nvPr/>
        </p:nvSpPr>
        <p:spPr>
          <a:xfrm>
            <a:off x="565816" y="0"/>
            <a:ext cx="27657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noProof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Jiao </a:t>
            </a:r>
            <a:r>
              <a:rPr lang="en-US" altLang="zh-CN" sz="1200" b="1" i="1" noProof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et al.  </a:t>
            </a:r>
            <a:r>
              <a:rPr lang="en-US" altLang="zh-CN" sz="1200" b="1" noProof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able S1</a:t>
            </a:r>
            <a:endParaRPr lang="zh-CN" altLang="en-US" sz="1200" b="1" noProof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954837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7</TotalTime>
  <Words>2004</Words>
  <Application>Microsoft Office PowerPoint</Application>
  <PresentationFormat>宽屏</PresentationFormat>
  <Paragraphs>1761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天慧 焦</dc:creator>
  <cp:lastModifiedBy>天慧 焦</cp:lastModifiedBy>
  <cp:revision>4</cp:revision>
  <dcterms:created xsi:type="dcterms:W3CDTF">2025-12-02T09:33:52Z</dcterms:created>
  <dcterms:modified xsi:type="dcterms:W3CDTF">2026-01-12T03:03:23Z</dcterms:modified>
</cp:coreProperties>
</file>